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56.tif" ContentType="image/tiff"/>
  <Override PartName="/ppt/media/image55.tif" ContentType="image/tiff"/>
  <Override PartName="/ppt/media/image54.tif" ContentType="image/tiff"/>
  <Override PartName="/ppt/media/image53.tif" ContentType="image/tiff"/>
  <Override PartName="/ppt/media/image52.tif" ContentType="image/tiff"/>
  <Override PartName="/ppt/media/image51.tif" ContentType="image/tiff"/>
  <Override PartName="/ppt/media/image50.tif" ContentType="image/tiff"/>
  <Override PartName="/ppt/media/image46.tif" ContentType="image/tiff"/>
  <Override PartName="/ppt/media/image75.jpeg" ContentType="image/jpeg"/>
  <Override PartName="/ppt/media/image45.tif" ContentType="image/tiff"/>
  <Override PartName="/ppt/media/image44.tif" ContentType="image/tiff"/>
  <Override PartName="/ppt/media/image42.tif" ContentType="image/tiff"/>
  <Override PartName="/ppt/media/image41.tif" ContentType="image/tiff"/>
  <Override PartName="/ppt/media/image19.jpeg" ContentType="image/jpeg"/>
  <Override PartName="/ppt/media/image40.tif" ContentType="image/tiff"/>
  <Override PartName="/ppt/media/image30.tif" ContentType="image/tiff"/>
  <Override PartName="/ppt/media/image39.tif" ContentType="image/tiff"/>
  <Override PartName="/ppt/media/image9.tif" ContentType="image/tiff"/>
  <Override PartName="/ppt/media/image86.tif" ContentType="image/tiff"/>
  <Override PartName="/ppt/media/image13.tif" ContentType="image/tiff"/>
  <Override PartName="/ppt/media/image1.tif" ContentType="image/tiff"/>
  <Override PartName="/ppt/media/image38.tif" ContentType="image/tiff"/>
  <Override PartName="/ppt/media/image8.tif" ContentType="image/tiff"/>
  <Override PartName="/ppt/media/image85.tif" ContentType="image/tiff"/>
  <Override PartName="/ppt/media/image49.tif" ContentType="image/tiff"/>
  <Override PartName="/ppt/media/image12.tif" ContentType="image/tiff"/>
  <Override PartName="/ppt/media/image24.png" ContentType="image/png"/>
  <Override PartName="/ppt/media/image26.tif" ContentType="image/tiff"/>
  <Override PartName="/ppt/media/image73.jpeg" ContentType="image/jpeg"/>
  <Override PartName="/ppt/media/image91.tif" ContentType="image/tiff"/>
  <Override PartName="/ppt/media/image37.tif" ContentType="image/tiff"/>
  <Override PartName="/ppt/media/image7.tif" ContentType="image/tiff"/>
  <Override PartName="/ppt/media/image84.tif" ContentType="image/tiff"/>
  <Override PartName="/ppt/media/image48.tif" ContentType="image/tiff"/>
  <Override PartName="/ppt/media/image43.tif" ContentType="image/tiff"/>
  <Override PartName="/ppt/media/image17.jpeg" ContentType="image/jpeg"/>
  <Override PartName="/ppt/media/image21.tif" ContentType="image/tiff"/>
  <Override PartName="/ppt/media/image58.tif" ContentType="image/tiff"/>
  <Override PartName="/ppt/media/image57.tif" ContentType="image/tiff"/>
  <Override PartName="/ppt/media/image20.jpeg" ContentType="image/jpeg"/>
  <Override PartName="/ppt/media/image22.tif" ContentType="image/tiff"/>
  <Override PartName="/ppt/media/image59.tif" ContentType="image/tiff"/>
  <Override PartName="/ppt/media/image23.tif" ContentType="image/tiff"/>
  <Override PartName="/ppt/media/image60.tif" ContentType="image/tiff"/>
  <Override PartName="/ppt/media/image61.tif" ContentType="image/tiff"/>
  <Override PartName="/ppt/media/image62.tif" ContentType="image/tiff"/>
  <Override PartName="/ppt/media/image63.tif" ContentType="image/tiff"/>
  <Override PartName="/ppt/media/image64.tif" ContentType="image/tiff"/>
  <Override PartName="/ppt/media/image65.tif" ContentType="image/tiff"/>
  <Override PartName="/ppt/media/image66.tif" ContentType="image/tiff"/>
  <Override PartName="/ppt/media/image89.tif" ContentType="image/tiff"/>
  <Override PartName="/ppt/media/image77.tif" ContentType="image/tiff"/>
  <Override PartName="/ppt/media/image88.tif" ContentType="image/tiff"/>
  <Override PartName="/ppt/media/image76.tif" ContentType="image/tiff"/>
  <Override PartName="/ppt/media/image87.tif" ContentType="image/tiff"/>
  <Override PartName="/ppt/media/image79.tif" ContentType="image/tiff"/>
  <Override PartName="/ppt/media/image67.tif" ContentType="image/tiff"/>
  <Override PartName="/ppt/media/image78.tif" ContentType="image/tiff"/>
  <Override PartName="/ppt/media/image72.tif" ContentType="image/tiff"/>
  <Override PartName="/ppt/media/image71.tif" ContentType="image/tiff"/>
  <Override PartName="/ppt/media/image92.png" ContentType="image/png"/>
  <Override PartName="/ppt/media/image29.tif" ContentType="image/tiff"/>
  <Override PartName="/ppt/media/image69.tif" ContentType="image/tiff"/>
  <Override PartName="/ppt/media/image32.tif" ContentType="image/tiff"/>
  <Override PartName="/ppt/media/image70.tif" ContentType="image/tiff"/>
  <Override PartName="/ppt/media/image68.tif" ContentType="image/tiff"/>
  <Override PartName="/ppt/media/image31.tif" ContentType="image/tiff"/>
  <Override PartName="/ppt/media/image11.tif" ContentType="image/tiff"/>
  <Override PartName="/ppt/media/image90.tif" ContentType="image/tiff"/>
  <Override PartName="/ppt/media/image25.tif" ContentType="image/tiff"/>
  <Override PartName="/ppt/media/image2.tif" ContentType="image/tiff"/>
  <Override PartName="/ppt/media/image14.tif" ContentType="image/tiff"/>
  <Override PartName="/ppt/media/image28.tif" ContentType="image/tiff"/>
  <Override PartName="/ppt/media/image93.tif" ContentType="image/tiff"/>
  <Override PartName="/ppt/media/image80.tif" ContentType="image/tiff"/>
  <Override PartName="/ppt/media/image15.tif" ContentType="image/tiff"/>
  <Override PartName="/ppt/media/image3.tif" ContentType="image/tiff"/>
  <Override PartName="/ppt/media/image33.tif" ContentType="image/tiff"/>
  <Override PartName="/ppt/media/image27.tif" ContentType="image/tiff"/>
  <Override PartName="/ppt/media/image81.tif" ContentType="image/tiff"/>
  <Override PartName="/ppt/media/image16.tif" ContentType="image/tiff"/>
  <Override PartName="/ppt/media/image4.tif" ContentType="image/tiff"/>
  <Override PartName="/ppt/media/image34.tif" ContentType="image/tiff"/>
  <Override PartName="/ppt/media/image82.tif" ContentType="image/tiff"/>
  <Override PartName="/ppt/media/image5.tif" ContentType="image/tiff"/>
  <Override PartName="/ppt/media/image35.tif" ContentType="image/tiff"/>
  <Override PartName="/ppt/media/image10.tif" ContentType="image/tiff"/>
  <Override PartName="/ppt/media/image47.tif" ContentType="image/tiff"/>
  <Override PartName="/ppt/media/image18.tif" ContentType="image/tiff"/>
  <Override PartName="/ppt/media/image83.tif" ContentType="image/tiff"/>
  <Override PartName="/ppt/media/image6.tif" ContentType="image/tiff"/>
  <Override PartName="/ppt/media/image74.jpeg" ContentType="image/jpeg"/>
  <Override PartName="/ppt/media/image36.tif" ContentType="image/tif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8EF06-6F09-4733-BA3F-9D3A55012F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04F7C-1D7F-4CF3-A6D5-47204B3263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B12DB9-2F23-4254-8ADB-CCBD75A6A4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807F1-94A6-42CC-A488-E264BF2634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F5F0A08-A1E3-4789-99B7-6DEBEFA14F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92D2E14-8B06-4A0A-9E0B-ADBD869FEB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65D6F33-F66E-46E6-B7AF-1DA0C35786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0A38303-CC81-4344-9CBA-985712DB87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000622D-4832-4FD9-A691-FF2245B504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9129726-CF96-4B77-9E68-02BDD1E71D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D064E90-079D-4AE1-9330-63F884AB61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2DDF0-96C6-4696-A0F4-4846229BD4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FC14C91-C66F-4774-9BB5-A78442967C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AE0A94D-259C-471E-B03F-CD9AB6E9D2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4AE8770-6759-4DAD-ABF9-163EEA56D8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16E23C9-FBB5-440F-A2B5-AC533284C7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B5AF06D-2B79-4E1D-8E75-7AC6A368FA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A66DA-75A6-482F-91EE-DF356B52D7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63AC3-98AA-46F4-B900-71B28DE593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8006A-335D-4C70-84C1-1632AFCAAA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8E9002-D9F5-4C9C-8FAC-E6BC2FB119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599F3-5163-461E-A3B2-A0E1F7822C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DFDC05-E449-4EC7-91AE-186007BBF6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024B2-3690-44F9-B3DE-62BB2AA0BC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C2ADD4-43EB-4EB4-A278-917A5A6AEC71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E52FAD-196A-4F6C-BD3B-B57E3CBBE682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image" Target="../media/image2.tif"/><Relationship Id="rId3" Type="http://schemas.openxmlformats.org/officeDocument/2006/relationships/image" Target="../media/image3.tif"/><Relationship Id="rId4" Type="http://schemas.openxmlformats.org/officeDocument/2006/relationships/image" Target="../media/image4.tif"/><Relationship Id="rId5" Type="http://schemas.openxmlformats.org/officeDocument/2006/relationships/image" Target="../media/image5.tif"/><Relationship Id="rId6" Type="http://schemas.openxmlformats.org/officeDocument/2006/relationships/image" Target="../media/image6.tif"/><Relationship Id="rId7" Type="http://schemas.openxmlformats.org/officeDocument/2006/relationships/image" Target="../media/image7.tif"/><Relationship Id="rId8" Type="http://schemas.openxmlformats.org/officeDocument/2006/relationships/image" Target="../media/image8.tif"/><Relationship Id="rId9" Type="http://schemas.openxmlformats.org/officeDocument/2006/relationships/image" Target="../media/image9.tif"/><Relationship Id="rId10" Type="http://schemas.openxmlformats.org/officeDocument/2006/relationships/image" Target="../media/image10.tif"/><Relationship Id="rId11" Type="http://schemas.openxmlformats.org/officeDocument/2006/relationships/image" Target="../media/image11.tif"/><Relationship Id="rId12" Type="http://schemas.openxmlformats.org/officeDocument/2006/relationships/image" Target="../media/image12.tif"/><Relationship Id="rId13" Type="http://schemas.openxmlformats.org/officeDocument/2006/relationships/image" Target="../media/image13.tif"/><Relationship Id="rId14" Type="http://schemas.openxmlformats.org/officeDocument/2006/relationships/image" Target="../media/image14.tif"/><Relationship Id="rId15" Type="http://schemas.openxmlformats.org/officeDocument/2006/relationships/image" Target="../media/image15.tif"/><Relationship Id="rId16" Type="http://schemas.openxmlformats.org/officeDocument/2006/relationships/image" Target="../media/image16.tif"/><Relationship Id="rId17" Type="http://schemas.openxmlformats.org/officeDocument/2006/relationships/image" Target="../media/image17.jpeg"/><Relationship Id="rId18" Type="http://schemas.openxmlformats.org/officeDocument/2006/relationships/image" Target="../media/image18.tif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tif"/><Relationship Id="rId22" Type="http://schemas.openxmlformats.org/officeDocument/2006/relationships/image" Target="../media/image22.tif"/><Relationship Id="rId23" Type="http://schemas.openxmlformats.org/officeDocument/2006/relationships/image" Target="../media/image23.tif"/><Relationship Id="rId24" Type="http://schemas.openxmlformats.org/officeDocument/2006/relationships/image" Target="../media/image24.png"/><Relationship Id="rId2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5.tif"/><Relationship Id="rId2" Type="http://schemas.openxmlformats.org/officeDocument/2006/relationships/image" Target="../media/image26.tif"/><Relationship Id="rId3" Type="http://schemas.openxmlformats.org/officeDocument/2006/relationships/image" Target="../media/image27.tif"/><Relationship Id="rId4" Type="http://schemas.openxmlformats.org/officeDocument/2006/relationships/image" Target="../media/image28.tif"/><Relationship Id="rId5" Type="http://schemas.openxmlformats.org/officeDocument/2006/relationships/image" Target="../media/image29.tif"/><Relationship Id="rId6" Type="http://schemas.openxmlformats.org/officeDocument/2006/relationships/image" Target="../media/image30.tif"/><Relationship Id="rId7" Type="http://schemas.openxmlformats.org/officeDocument/2006/relationships/image" Target="../media/image31.tif"/><Relationship Id="rId8" Type="http://schemas.openxmlformats.org/officeDocument/2006/relationships/image" Target="../media/image32.tif"/><Relationship Id="rId9" Type="http://schemas.openxmlformats.org/officeDocument/2006/relationships/image" Target="../media/image33.tif"/><Relationship Id="rId10" Type="http://schemas.openxmlformats.org/officeDocument/2006/relationships/image" Target="../media/image34.tif"/><Relationship Id="rId11" Type="http://schemas.openxmlformats.org/officeDocument/2006/relationships/image" Target="../media/image35.tif"/><Relationship Id="rId12" Type="http://schemas.openxmlformats.org/officeDocument/2006/relationships/image" Target="../media/image36.tif"/><Relationship Id="rId13" Type="http://schemas.openxmlformats.org/officeDocument/2006/relationships/image" Target="../media/image37.tif"/><Relationship Id="rId14" Type="http://schemas.openxmlformats.org/officeDocument/2006/relationships/image" Target="../media/image38.tif"/><Relationship Id="rId15" Type="http://schemas.openxmlformats.org/officeDocument/2006/relationships/image" Target="../media/image39.tif"/><Relationship Id="rId16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0.tif"/><Relationship Id="rId2" Type="http://schemas.openxmlformats.org/officeDocument/2006/relationships/image" Target="../media/image41.tif"/><Relationship Id="rId3" Type="http://schemas.openxmlformats.org/officeDocument/2006/relationships/image" Target="../media/image42.tif"/><Relationship Id="rId4" Type="http://schemas.openxmlformats.org/officeDocument/2006/relationships/image" Target="../media/image43.tif"/><Relationship Id="rId5" Type="http://schemas.openxmlformats.org/officeDocument/2006/relationships/image" Target="../media/image44.tif"/><Relationship Id="rId6" Type="http://schemas.openxmlformats.org/officeDocument/2006/relationships/image" Target="../media/image45.tif"/><Relationship Id="rId7" Type="http://schemas.openxmlformats.org/officeDocument/2006/relationships/image" Target="../media/image46.tif"/><Relationship Id="rId8" Type="http://schemas.openxmlformats.org/officeDocument/2006/relationships/image" Target="../media/image47.tif"/><Relationship Id="rId9" Type="http://schemas.openxmlformats.org/officeDocument/2006/relationships/image" Target="../media/image48.tif"/><Relationship Id="rId10" Type="http://schemas.openxmlformats.org/officeDocument/2006/relationships/image" Target="../media/image49.tif"/><Relationship Id="rId11" Type="http://schemas.openxmlformats.org/officeDocument/2006/relationships/image" Target="../media/image50.tif"/><Relationship Id="rId12" Type="http://schemas.openxmlformats.org/officeDocument/2006/relationships/image" Target="../media/image51.tif"/><Relationship Id="rId13" Type="http://schemas.openxmlformats.org/officeDocument/2006/relationships/image" Target="../media/image52.tif"/><Relationship Id="rId14" Type="http://schemas.openxmlformats.org/officeDocument/2006/relationships/image" Target="../media/image53.tif"/><Relationship Id="rId15" Type="http://schemas.openxmlformats.org/officeDocument/2006/relationships/image" Target="../media/image54.tif"/><Relationship Id="rId16" Type="http://schemas.openxmlformats.org/officeDocument/2006/relationships/image" Target="../media/image55.tif"/><Relationship Id="rId17" Type="http://schemas.openxmlformats.org/officeDocument/2006/relationships/image" Target="../media/image56.tif"/><Relationship Id="rId18" Type="http://schemas.openxmlformats.org/officeDocument/2006/relationships/image" Target="../media/image57.tif"/><Relationship Id="rId19" Type="http://schemas.openxmlformats.org/officeDocument/2006/relationships/image" Target="../media/image58.tif"/><Relationship Id="rId20" Type="http://schemas.openxmlformats.org/officeDocument/2006/relationships/image" Target="../media/image59.tif"/><Relationship Id="rId21" Type="http://schemas.openxmlformats.org/officeDocument/2006/relationships/image" Target="../media/image60.tif"/><Relationship Id="rId22" Type="http://schemas.openxmlformats.org/officeDocument/2006/relationships/slideLayout" Target="../slideLayouts/slideLayout1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1.tif"/><Relationship Id="rId2" Type="http://schemas.openxmlformats.org/officeDocument/2006/relationships/image" Target="../media/image62.tif"/><Relationship Id="rId3" Type="http://schemas.openxmlformats.org/officeDocument/2006/relationships/image" Target="../media/image63.tif"/><Relationship Id="rId4" Type="http://schemas.openxmlformats.org/officeDocument/2006/relationships/image" Target="../media/image64.tif"/><Relationship Id="rId5" Type="http://schemas.openxmlformats.org/officeDocument/2006/relationships/image" Target="../media/image65.tif"/><Relationship Id="rId6" Type="http://schemas.openxmlformats.org/officeDocument/2006/relationships/image" Target="../media/image66.tif"/><Relationship Id="rId7" Type="http://schemas.openxmlformats.org/officeDocument/2006/relationships/image" Target="../media/image67.tif"/><Relationship Id="rId8" Type="http://schemas.openxmlformats.org/officeDocument/2006/relationships/image" Target="../media/image68.tif"/><Relationship Id="rId9" Type="http://schemas.openxmlformats.org/officeDocument/2006/relationships/image" Target="../media/image69.tif"/><Relationship Id="rId10" Type="http://schemas.openxmlformats.org/officeDocument/2006/relationships/image" Target="../media/image70.tif"/><Relationship Id="rId11" Type="http://schemas.openxmlformats.org/officeDocument/2006/relationships/image" Target="../media/image71.tif"/><Relationship Id="rId12" Type="http://schemas.openxmlformats.org/officeDocument/2006/relationships/image" Target="../media/image72.tif"/><Relationship Id="rId13" Type="http://schemas.openxmlformats.org/officeDocument/2006/relationships/image" Target="../media/image73.jpeg"/><Relationship Id="rId14" Type="http://schemas.openxmlformats.org/officeDocument/2006/relationships/image" Target="../media/image74.jpeg"/><Relationship Id="rId15" Type="http://schemas.openxmlformats.org/officeDocument/2006/relationships/image" Target="../media/image75.jpeg"/><Relationship Id="rId16" Type="http://schemas.openxmlformats.org/officeDocument/2006/relationships/image" Target="../media/image76.tif"/><Relationship Id="rId17" Type="http://schemas.openxmlformats.org/officeDocument/2006/relationships/image" Target="../media/image77.tif"/><Relationship Id="rId18" Type="http://schemas.openxmlformats.org/officeDocument/2006/relationships/image" Target="../media/image78.tif"/><Relationship Id="rId19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9.tif"/><Relationship Id="rId2" Type="http://schemas.openxmlformats.org/officeDocument/2006/relationships/image" Target="../media/image80.tif"/><Relationship Id="rId3" Type="http://schemas.openxmlformats.org/officeDocument/2006/relationships/image" Target="../media/image81.tif"/><Relationship Id="rId4" Type="http://schemas.openxmlformats.org/officeDocument/2006/relationships/image" Target="../media/image82.tif"/><Relationship Id="rId5" Type="http://schemas.openxmlformats.org/officeDocument/2006/relationships/image" Target="../media/image83.tif"/><Relationship Id="rId6" Type="http://schemas.openxmlformats.org/officeDocument/2006/relationships/image" Target="../media/image84.tif"/><Relationship Id="rId7" Type="http://schemas.openxmlformats.org/officeDocument/2006/relationships/image" Target="../media/image85.tif"/><Relationship Id="rId8" Type="http://schemas.openxmlformats.org/officeDocument/2006/relationships/image" Target="../media/image86.tif"/><Relationship Id="rId9" Type="http://schemas.openxmlformats.org/officeDocument/2006/relationships/image" Target="../media/image87.tif"/><Relationship Id="rId10" Type="http://schemas.openxmlformats.org/officeDocument/2006/relationships/image" Target="../media/image88.tif"/><Relationship Id="rId11" Type="http://schemas.openxmlformats.org/officeDocument/2006/relationships/image" Target="../media/image89.tif"/><Relationship Id="rId12" Type="http://schemas.openxmlformats.org/officeDocument/2006/relationships/image" Target="../media/image90.tif"/><Relationship Id="rId13" Type="http://schemas.openxmlformats.org/officeDocument/2006/relationships/image" Target="../media/image91.tif"/><Relationship Id="rId14" Type="http://schemas.openxmlformats.org/officeDocument/2006/relationships/image" Target="../media/image92.png"/><Relationship Id="rId15" Type="http://schemas.openxmlformats.org/officeDocument/2006/relationships/image" Target="../media/image93.tif"/><Relationship Id="rId16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组合 17"/>
          <p:cNvGrpSpPr/>
          <p:nvPr/>
        </p:nvGrpSpPr>
        <p:grpSpPr>
          <a:xfrm>
            <a:off x="135000" y="3543480"/>
            <a:ext cx="3808080" cy="1575720"/>
            <a:chOff x="135000" y="3543480"/>
            <a:chExt cx="3808080" cy="1575720"/>
          </a:xfrm>
        </p:grpSpPr>
        <p:grpSp>
          <p:nvGrpSpPr>
            <p:cNvPr id="83" name="组合 6"/>
            <p:cNvGrpSpPr/>
            <p:nvPr/>
          </p:nvGrpSpPr>
          <p:grpSpPr>
            <a:xfrm>
              <a:off x="410400" y="3543480"/>
              <a:ext cx="3532680" cy="1491840"/>
              <a:chOff x="410400" y="3543480"/>
              <a:chExt cx="3532680" cy="1491840"/>
            </a:xfrm>
          </p:grpSpPr>
          <p:pic>
            <p:nvPicPr>
              <p:cNvPr id="84" name="图片 1" descr="mmp-THP-1"/>
              <p:cNvPicPr/>
              <p:nvPr/>
            </p:nvPicPr>
            <p:blipFill>
              <a:blip r:embed="rId1"/>
              <a:srcRect l="789541" t="396262" r="789541" b="622741"/>
              <a:stretch/>
            </p:blipFill>
            <p:spPr>
              <a:xfrm>
                <a:off x="410400" y="3543480"/>
                <a:ext cx="1030320" cy="1491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5" name="图片 2" descr="mmp-THP-2-2"/>
              <p:cNvPicPr/>
              <p:nvPr/>
            </p:nvPicPr>
            <p:blipFill>
              <a:blip r:embed="rId2"/>
              <a:srcRect l="730867" t="793458" r="847704" b="226480"/>
              <a:stretch/>
            </p:blipFill>
            <p:spPr>
              <a:xfrm>
                <a:off x="2911320" y="3544560"/>
                <a:ext cx="1031760" cy="1490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6" name="图片 3" descr="mmp-THP-3-2"/>
              <p:cNvPicPr/>
              <p:nvPr/>
            </p:nvPicPr>
            <p:blipFill>
              <a:blip r:embed="rId3"/>
              <a:srcRect l="811735" t="694393" r="766582" b="325545"/>
              <a:stretch/>
            </p:blipFill>
            <p:spPr>
              <a:xfrm>
                <a:off x="1634400" y="3544560"/>
                <a:ext cx="1031760" cy="14904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87" name="文本框 12"/>
            <p:cNvSpPr/>
            <p:nvPr/>
          </p:nvSpPr>
          <p:spPr>
            <a:xfrm rot="16200000">
              <a:off x="-500400" y="4206960"/>
              <a:ext cx="1547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HP-1 MMP8 55K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组合 15"/>
          <p:cNvGrpSpPr/>
          <p:nvPr/>
        </p:nvGrpSpPr>
        <p:grpSpPr>
          <a:xfrm>
            <a:off x="4633920" y="3544920"/>
            <a:ext cx="3809160" cy="1490400"/>
            <a:chOff x="4633920" y="3544920"/>
            <a:chExt cx="3809160" cy="1490400"/>
          </a:xfrm>
        </p:grpSpPr>
        <p:grpSp>
          <p:nvGrpSpPr>
            <p:cNvPr id="89" name="组合 10"/>
            <p:cNvGrpSpPr/>
            <p:nvPr/>
          </p:nvGrpSpPr>
          <p:grpSpPr>
            <a:xfrm>
              <a:off x="4909320" y="3544920"/>
              <a:ext cx="3533760" cy="1490040"/>
              <a:chOff x="4909320" y="3544920"/>
              <a:chExt cx="3533760" cy="1490040"/>
            </a:xfrm>
          </p:grpSpPr>
          <p:pic>
            <p:nvPicPr>
              <p:cNvPr id="90" name="图片 7" descr="mmp-RAW-1"/>
              <p:cNvPicPr/>
              <p:nvPr/>
            </p:nvPicPr>
            <p:blipFill>
              <a:blip r:embed="rId4"/>
              <a:srcRect l="730102" t="396262" r="848214" b="623676"/>
              <a:stretch/>
            </p:blipFill>
            <p:spPr>
              <a:xfrm>
                <a:off x="4909320" y="3544920"/>
                <a:ext cx="103212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1" name="图片 8" descr="mmp-RAW-2-1"/>
              <p:cNvPicPr/>
              <p:nvPr/>
            </p:nvPicPr>
            <p:blipFill>
              <a:blip r:embed="rId5"/>
              <a:srcRect l="649235" t="396262" r="929847" b="623676"/>
              <a:stretch/>
            </p:blipFill>
            <p:spPr>
              <a:xfrm>
                <a:off x="7411680" y="3544920"/>
                <a:ext cx="103140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2" name="图片 9" descr="mmp-RAW-3-2"/>
              <p:cNvPicPr/>
              <p:nvPr/>
            </p:nvPicPr>
            <p:blipFill>
              <a:blip r:embed="rId6"/>
              <a:srcRect l="878814" t="411886" r="825847" b="826615"/>
              <a:stretch/>
            </p:blipFill>
            <p:spPr>
              <a:xfrm>
                <a:off x="6162480" y="3544920"/>
                <a:ext cx="1028160" cy="14900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93" name="文本框 14"/>
            <p:cNvSpPr/>
            <p:nvPr/>
          </p:nvSpPr>
          <p:spPr>
            <a:xfrm rot="16200000">
              <a:off x="4028400" y="4153320"/>
              <a:ext cx="148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RAW264.7 MMP8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4" name="组合 28"/>
          <p:cNvGrpSpPr/>
          <p:nvPr/>
        </p:nvGrpSpPr>
        <p:grpSpPr>
          <a:xfrm>
            <a:off x="149400" y="5133600"/>
            <a:ext cx="3806640" cy="1644840"/>
            <a:chOff x="149400" y="5133600"/>
            <a:chExt cx="3806640" cy="1644840"/>
          </a:xfrm>
        </p:grpSpPr>
        <p:grpSp>
          <p:nvGrpSpPr>
            <p:cNvPr id="95" name="组合 27"/>
            <p:cNvGrpSpPr/>
            <p:nvPr/>
          </p:nvGrpSpPr>
          <p:grpSpPr>
            <a:xfrm>
              <a:off x="424800" y="5155920"/>
              <a:ext cx="3531240" cy="1491840"/>
              <a:chOff x="424800" y="5155920"/>
              <a:chExt cx="3531240" cy="1491840"/>
            </a:xfrm>
          </p:grpSpPr>
          <p:pic>
            <p:nvPicPr>
              <p:cNvPr id="96" name="图片 26" descr="gapdh5-1"/>
              <p:cNvPicPr/>
              <p:nvPr/>
            </p:nvPicPr>
            <p:blipFill>
              <a:blip r:embed="rId7"/>
              <a:srcRect l="803341" t="630978" r="867261" b="550815"/>
              <a:stretch/>
            </p:blipFill>
            <p:spPr>
              <a:xfrm>
                <a:off x="1674720" y="5155920"/>
                <a:ext cx="1031040" cy="1491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7" name="图片 19" descr="gapdh2"/>
              <p:cNvPicPr/>
              <p:nvPr/>
            </p:nvPicPr>
            <p:blipFill>
              <a:blip r:embed="rId8"/>
              <a:srcRect l="598246" t="292355" r="993233" b="749847"/>
              <a:stretch/>
            </p:blipFill>
            <p:spPr>
              <a:xfrm>
                <a:off x="424800" y="5155920"/>
                <a:ext cx="1031040" cy="1491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8" name="图片 18" descr="gapdh1"/>
              <p:cNvPicPr/>
              <p:nvPr/>
            </p:nvPicPr>
            <p:blipFill>
              <a:blip r:embed="rId9"/>
              <a:srcRect l="690816" t="396262" r="888520" b="623676"/>
              <a:stretch/>
            </p:blipFill>
            <p:spPr>
              <a:xfrm>
                <a:off x="2925000" y="5155920"/>
                <a:ext cx="1031040" cy="14918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99" name="文本框 24"/>
            <p:cNvSpPr/>
            <p:nvPr/>
          </p:nvSpPr>
          <p:spPr>
            <a:xfrm rot="16200000">
              <a:off x="-534600" y="5817600"/>
              <a:ext cx="164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HP-1 GAPDH 36K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文本框 29"/>
          <p:cNvSpPr/>
          <p:nvPr/>
        </p:nvSpPr>
        <p:spPr>
          <a:xfrm>
            <a:off x="423720" y="0"/>
            <a:ext cx="221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on  L/I12h  L/I24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组合 61"/>
          <p:cNvGrpSpPr/>
          <p:nvPr/>
        </p:nvGrpSpPr>
        <p:grpSpPr>
          <a:xfrm>
            <a:off x="135000" y="240840"/>
            <a:ext cx="3808440" cy="1568880"/>
            <a:chOff x="135000" y="240840"/>
            <a:chExt cx="3808440" cy="1568880"/>
          </a:xfrm>
        </p:grpSpPr>
        <p:pic>
          <p:nvPicPr>
            <p:cNvPr id="102" name="图片 58" descr="THP-NOS-1-1"/>
            <p:cNvPicPr/>
            <p:nvPr/>
          </p:nvPicPr>
          <p:blipFill>
            <a:blip r:embed="rId10"/>
            <a:srcRect l="912352" t="260580" r="717102" b="848406"/>
            <a:stretch/>
          </p:blipFill>
          <p:spPr>
            <a:xfrm>
              <a:off x="2912400" y="318600"/>
              <a:ext cx="1031040" cy="149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图片 59" descr="THP-NOS-2-1"/>
            <p:cNvPicPr/>
            <p:nvPr/>
          </p:nvPicPr>
          <p:blipFill>
            <a:blip r:embed="rId11"/>
            <a:srcRect l="862264" t="229683" r="771462" b="887032"/>
            <a:stretch/>
          </p:blipFill>
          <p:spPr>
            <a:xfrm>
              <a:off x="1661040" y="318600"/>
              <a:ext cx="1030680" cy="149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图片 60" descr="THP-NOS-3-1"/>
            <p:cNvPicPr/>
            <p:nvPr/>
          </p:nvPicPr>
          <p:blipFill>
            <a:blip r:embed="rId12"/>
            <a:srcRect l="833666" t="242378" r="760599" b="804268"/>
            <a:stretch/>
          </p:blipFill>
          <p:spPr>
            <a:xfrm>
              <a:off x="409680" y="318600"/>
              <a:ext cx="1031040" cy="149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文本框 30"/>
            <p:cNvSpPr/>
            <p:nvPr/>
          </p:nvSpPr>
          <p:spPr>
            <a:xfrm rot="16200000">
              <a:off x="-499680" y="875520"/>
              <a:ext cx="1546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HP-1 iNOS 131K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6" name="组合 50"/>
          <p:cNvGrpSpPr/>
          <p:nvPr/>
        </p:nvGrpSpPr>
        <p:grpSpPr>
          <a:xfrm>
            <a:off x="149400" y="1922400"/>
            <a:ext cx="3794040" cy="1499760"/>
            <a:chOff x="149400" y="1922400"/>
            <a:chExt cx="3794040" cy="1499760"/>
          </a:xfrm>
        </p:grpSpPr>
        <p:pic>
          <p:nvPicPr>
            <p:cNvPr id="107" name="图片 45" descr="THP-CD86-3-1"/>
            <p:cNvPicPr/>
            <p:nvPr/>
          </p:nvPicPr>
          <p:blipFill>
            <a:blip r:embed="rId13"/>
            <a:srcRect l="924297" t="254688" r="641432" b="760313"/>
            <a:stretch/>
          </p:blipFill>
          <p:spPr>
            <a:xfrm>
              <a:off x="425520" y="1936080"/>
              <a:ext cx="1045440" cy="1486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图片 46" descr="THP-CD86-2-1"/>
            <p:cNvPicPr/>
            <p:nvPr/>
          </p:nvPicPr>
          <p:blipFill>
            <a:blip r:embed="rId14"/>
            <a:srcRect l="813144" t="244969" r="767268" b="761006"/>
            <a:stretch/>
          </p:blipFill>
          <p:spPr>
            <a:xfrm>
              <a:off x="1683000" y="1936080"/>
              <a:ext cx="1017720" cy="1486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图片 44" descr="THP-CD86-4-1"/>
            <p:cNvPicPr/>
            <p:nvPr/>
          </p:nvPicPr>
          <p:blipFill>
            <a:blip r:embed="rId15"/>
            <a:srcRect l="732316" t="182919" r="848346" b="838820"/>
            <a:stretch/>
          </p:blipFill>
          <p:spPr>
            <a:xfrm>
              <a:off x="2913120" y="1936080"/>
              <a:ext cx="1030320" cy="1486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0" name="文本框 32"/>
            <p:cNvSpPr/>
            <p:nvPr/>
          </p:nvSpPr>
          <p:spPr>
            <a:xfrm rot="16200000">
              <a:off x="-460080" y="2532240"/>
              <a:ext cx="1496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HP-1 CD86 75K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文本框 33"/>
          <p:cNvSpPr/>
          <p:nvPr/>
        </p:nvSpPr>
        <p:spPr>
          <a:xfrm>
            <a:off x="4935600" y="0"/>
            <a:ext cx="221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on  L/I6h  L/I12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组合 54"/>
          <p:cNvGrpSpPr/>
          <p:nvPr/>
        </p:nvGrpSpPr>
        <p:grpSpPr>
          <a:xfrm>
            <a:off x="4659480" y="318960"/>
            <a:ext cx="3783960" cy="1490400"/>
            <a:chOff x="4659480" y="318960"/>
            <a:chExt cx="3783960" cy="1490400"/>
          </a:xfrm>
        </p:grpSpPr>
        <p:pic>
          <p:nvPicPr>
            <p:cNvPr id="113" name="图片 52" descr="RAW-NOS-5-1"/>
            <p:cNvPicPr/>
            <p:nvPr/>
          </p:nvPicPr>
          <p:blipFill>
            <a:blip r:embed="rId16"/>
            <a:srcRect l="752123" t="91354" r="883255" b="1025360"/>
            <a:stretch/>
          </p:blipFill>
          <p:spPr>
            <a:xfrm>
              <a:off x="7414920" y="318960"/>
              <a:ext cx="1028520" cy="149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图片 53" descr="RAW-NOS-4-1"/>
            <p:cNvPicPr/>
            <p:nvPr/>
          </p:nvPicPr>
          <p:blipFill>
            <a:blip r:embed="rId17"/>
            <a:srcRect l="35152" t="20719" r="33234" b="23447"/>
            <a:stretch/>
          </p:blipFill>
          <p:spPr>
            <a:xfrm>
              <a:off x="6174720" y="318960"/>
              <a:ext cx="1031040" cy="149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图片 51" descr="RAW-NOS-6-1"/>
            <p:cNvPicPr/>
            <p:nvPr/>
          </p:nvPicPr>
          <p:blipFill>
            <a:blip r:embed="rId18"/>
            <a:srcRect l="730867" t="125234" r="848214" b="894081"/>
            <a:stretch/>
          </p:blipFill>
          <p:spPr>
            <a:xfrm>
              <a:off x="4934880" y="318960"/>
              <a:ext cx="1030680" cy="149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6" name="文本框 34"/>
            <p:cNvSpPr/>
            <p:nvPr/>
          </p:nvSpPr>
          <p:spPr>
            <a:xfrm rot="16200000">
              <a:off x="4054320" y="927720"/>
              <a:ext cx="1486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RAW264.7 iNO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组合 43"/>
          <p:cNvGrpSpPr/>
          <p:nvPr/>
        </p:nvGrpSpPr>
        <p:grpSpPr>
          <a:xfrm>
            <a:off x="4657680" y="1932120"/>
            <a:ext cx="3786120" cy="1490400"/>
            <a:chOff x="4657680" y="1932120"/>
            <a:chExt cx="3786120" cy="1490400"/>
          </a:xfrm>
        </p:grpSpPr>
        <p:pic>
          <p:nvPicPr>
            <p:cNvPr id="118" name="图片 41" descr="RAW-CD86-2-1"/>
            <p:cNvPicPr/>
            <p:nvPr/>
          </p:nvPicPr>
          <p:blipFill>
            <a:blip r:embed="rId19"/>
            <a:srcRect l="33988" t="17420" r="37407" b="32140"/>
            <a:stretch/>
          </p:blipFill>
          <p:spPr>
            <a:xfrm>
              <a:off x="7412040" y="1932120"/>
              <a:ext cx="1031760" cy="149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9" name="图片 40" descr="RAW-CD86-1-1"/>
            <p:cNvPicPr/>
            <p:nvPr/>
          </p:nvPicPr>
          <p:blipFill>
            <a:blip r:embed="rId20"/>
            <a:srcRect l="35422" t="14129" r="34843" b="33418"/>
            <a:stretch/>
          </p:blipFill>
          <p:spPr>
            <a:xfrm>
              <a:off x="6172560" y="1932120"/>
              <a:ext cx="1031760" cy="149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0" name="图片 42" descr="RAW-CD86-3-1"/>
            <p:cNvPicPr/>
            <p:nvPr/>
          </p:nvPicPr>
          <p:blipFill>
            <a:blip r:embed="rId21"/>
            <a:srcRect l="811735" t="297508" r="766582" b="722430"/>
            <a:stretch/>
          </p:blipFill>
          <p:spPr>
            <a:xfrm>
              <a:off x="4933080" y="1932120"/>
              <a:ext cx="1031760" cy="149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文本框 36"/>
            <p:cNvSpPr/>
            <p:nvPr/>
          </p:nvSpPr>
          <p:spPr>
            <a:xfrm rot="16200000">
              <a:off x="4052160" y="2538000"/>
              <a:ext cx="1487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RAW264.7 CD86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2" name="组合 57"/>
          <p:cNvGrpSpPr/>
          <p:nvPr/>
        </p:nvGrpSpPr>
        <p:grpSpPr>
          <a:xfrm>
            <a:off x="4656240" y="5157720"/>
            <a:ext cx="3787200" cy="1489320"/>
            <a:chOff x="4656240" y="5157720"/>
            <a:chExt cx="3787200" cy="1489320"/>
          </a:xfrm>
        </p:grpSpPr>
        <p:pic>
          <p:nvPicPr>
            <p:cNvPr id="123" name="图片 55" descr="RAW-GAPDH-1"/>
            <p:cNvPicPr/>
            <p:nvPr/>
          </p:nvPicPr>
          <p:blipFill>
            <a:blip r:embed="rId22"/>
            <a:srcRect l="730414" t="469436" r="886131" b="610682"/>
            <a:stretch/>
          </p:blipFill>
          <p:spPr>
            <a:xfrm>
              <a:off x="6145560" y="5157720"/>
              <a:ext cx="1026000" cy="148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4" name="图片 56" descr="RAW-GAPDH-2"/>
            <p:cNvPicPr/>
            <p:nvPr/>
          </p:nvPicPr>
          <p:blipFill>
            <a:blip r:embed="rId23"/>
            <a:srcRect l="753938" t="482799" r="871360" b="618367"/>
            <a:stretch/>
          </p:blipFill>
          <p:spPr>
            <a:xfrm>
              <a:off x="7412400" y="5157720"/>
              <a:ext cx="1031040" cy="148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5" name="图片 20" descr="gapdh3-1"/>
            <p:cNvPicPr/>
            <p:nvPr/>
          </p:nvPicPr>
          <p:blipFill>
            <a:blip r:embed="rId24"/>
            <a:srcRect l="35495" t="34856" r="36121" b="13342"/>
            <a:stretch/>
          </p:blipFill>
          <p:spPr>
            <a:xfrm>
              <a:off x="4908240" y="5157720"/>
              <a:ext cx="996480" cy="1489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6" name="文本框 38"/>
            <p:cNvSpPr/>
            <p:nvPr/>
          </p:nvSpPr>
          <p:spPr>
            <a:xfrm rot="16200000">
              <a:off x="4051440" y="5764320"/>
              <a:ext cx="148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RAW264.7 GAPDH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7" name="组合 7"/>
          <p:cNvGrpSpPr/>
          <p:nvPr/>
        </p:nvGrpSpPr>
        <p:grpSpPr>
          <a:xfrm>
            <a:off x="196920" y="1874880"/>
            <a:ext cx="3809880" cy="1490760"/>
            <a:chOff x="196920" y="1874880"/>
            <a:chExt cx="3809880" cy="1490760"/>
          </a:xfrm>
        </p:grpSpPr>
        <p:pic>
          <p:nvPicPr>
            <p:cNvPr id="128" name="图片 1" descr="M8I-CD86-1-1"/>
            <p:cNvPicPr/>
            <p:nvPr/>
          </p:nvPicPr>
          <p:blipFill>
            <a:blip r:embed="rId1"/>
            <a:srcRect l="770408" t="280062" r="808929" b="739875"/>
            <a:stretch/>
          </p:blipFill>
          <p:spPr>
            <a:xfrm>
              <a:off x="2975760" y="1874880"/>
              <a:ext cx="1031040" cy="149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图片 2" descr="M8I-CD86-2-1"/>
            <p:cNvPicPr/>
            <p:nvPr/>
          </p:nvPicPr>
          <p:blipFill>
            <a:blip r:embed="rId2"/>
            <a:srcRect l="932908" t="379751" r="646429" b="640187"/>
            <a:stretch/>
          </p:blipFill>
          <p:spPr>
            <a:xfrm>
              <a:off x="473040" y="1874880"/>
              <a:ext cx="1031040" cy="149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图片 3" descr="M8I-CD86-3-1"/>
            <p:cNvPicPr/>
            <p:nvPr/>
          </p:nvPicPr>
          <p:blipFill>
            <a:blip r:embed="rId3"/>
            <a:srcRect l="688776" t="180997" r="890561" b="838941"/>
            <a:stretch/>
          </p:blipFill>
          <p:spPr>
            <a:xfrm>
              <a:off x="1724400" y="1874880"/>
              <a:ext cx="1030680" cy="149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1" name="文本框 5"/>
            <p:cNvSpPr/>
            <p:nvPr/>
          </p:nvSpPr>
          <p:spPr>
            <a:xfrm rot="16200000">
              <a:off x="-314640" y="2454480"/>
              <a:ext cx="13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D86 75K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2" name="文本框 29"/>
          <p:cNvSpPr/>
          <p:nvPr/>
        </p:nvSpPr>
        <p:spPr>
          <a:xfrm>
            <a:off x="471600" y="30240"/>
            <a:ext cx="221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0  L/I  M8I+L/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组合 12"/>
          <p:cNvGrpSpPr/>
          <p:nvPr/>
        </p:nvGrpSpPr>
        <p:grpSpPr>
          <a:xfrm>
            <a:off x="196920" y="303120"/>
            <a:ext cx="3809520" cy="1490760"/>
            <a:chOff x="196920" y="303120"/>
            <a:chExt cx="3809520" cy="1490760"/>
          </a:xfrm>
        </p:grpSpPr>
        <p:pic>
          <p:nvPicPr>
            <p:cNvPr id="134" name="图片 8" descr="M8I-INOS-1-1"/>
            <p:cNvPicPr/>
            <p:nvPr/>
          </p:nvPicPr>
          <p:blipFill>
            <a:blip r:embed="rId4"/>
            <a:srcRect l="752798" t="201780" r="860097" b="878338"/>
            <a:stretch/>
          </p:blipFill>
          <p:spPr>
            <a:xfrm>
              <a:off x="1724400" y="303120"/>
              <a:ext cx="1030680" cy="149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5" name="图片 9" descr="M8I-INOS-2-1"/>
            <p:cNvPicPr/>
            <p:nvPr/>
          </p:nvPicPr>
          <p:blipFill>
            <a:blip r:embed="rId5"/>
            <a:srcRect l="860688" t="191592" r="744717" b="874474"/>
            <a:stretch/>
          </p:blipFill>
          <p:spPr>
            <a:xfrm>
              <a:off x="2975760" y="303120"/>
              <a:ext cx="1030680" cy="149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6" name="图片 10" descr="M8I-INOS-3-1"/>
            <p:cNvPicPr/>
            <p:nvPr/>
          </p:nvPicPr>
          <p:blipFill>
            <a:blip r:embed="rId6"/>
            <a:srcRect l="987736" t="275216" r="645991" b="841210"/>
            <a:stretch/>
          </p:blipFill>
          <p:spPr>
            <a:xfrm>
              <a:off x="473040" y="303120"/>
              <a:ext cx="1031040" cy="149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7" name="文本框 11"/>
            <p:cNvSpPr/>
            <p:nvPr/>
          </p:nvSpPr>
          <p:spPr>
            <a:xfrm rot="16200000">
              <a:off x="-314640" y="908280"/>
              <a:ext cx="13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iNOS 131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8" name="组合 67"/>
          <p:cNvGrpSpPr/>
          <p:nvPr/>
        </p:nvGrpSpPr>
        <p:grpSpPr>
          <a:xfrm>
            <a:off x="196920" y="3446640"/>
            <a:ext cx="3813120" cy="1490400"/>
            <a:chOff x="196920" y="3446640"/>
            <a:chExt cx="3813120" cy="1490400"/>
          </a:xfrm>
        </p:grpSpPr>
        <p:pic>
          <p:nvPicPr>
            <p:cNvPr id="139" name="图片 66" descr="GAPDH21-1"/>
            <p:cNvPicPr/>
            <p:nvPr/>
          </p:nvPicPr>
          <p:blipFill>
            <a:blip r:embed="rId7"/>
            <a:srcRect l="1032388" t="243642" r="598818" b="868208"/>
            <a:stretch/>
          </p:blipFill>
          <p:spPr>
            <a:xfrm>
              <a:off x="2979000" y="3446640"/>
              <a:ext cx="1031040" cy="14904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0" name="组合 65"/>
            <p:cNvGrpSpPr/>
            <p:nvPr/>
          </p:nvGrpSpPr>
          <p:grpSpPr>
            <a:xfrm>
              <a:off x="196920" y="3447000"/>
              <a:ext cx="2557080" cy="1489680"/>
              <a:chOff x="196920" y="3447000"/>
              <a:chExt cx="2557080" cy="1489680"/>
            </a:xfrm>
          </p:grpSpPr>
          <p:pic>
            <p:nvPicPr>
              <p:cNvPr id="141" name="图片 64" descr="GAPDH2-1"/>
              <p:cNvPicPr/>
              <p:nvPr/>
            </p:nvPicPr>
            <p:blipFill>
              <a:blip r:embed="rId8"/>
              <a:srcRect l="883372" t="285593" r="764665" b="854802"/>
              <a:stretch/>
            </p:blipFill>
            <p:spPr>
              <a:xfrm>
                <a:off x="1724040" y="3447000"/>
                <a:ext cx="1029960" cy="1489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2" name="图片 32" descr="GAPDH1-1"/>
              <p:cNvPicPr/>
              <p:nvPr/>
            </p:nvPicPr>
            <p:blipFill>
              <a:blip r:embed="rId9"/>
              <a:srcRect l="883603" t="540113" r="763510" b="600282"/>
              <a:stretch/>
            </p:blipFill>
            <p:spPr>
              <a:xfrm>
                <a:off x="468360" y="3447000"/>
                <a:ext cx="1031040" cy="1489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3" name="文本框 18"/>
              <p:cNvSpPr/>
              <p:nvPr/>
            </p:nvSpPr>
            <p:spPr>
              <a:xfrm rot="16200000">
                <a:off x="-314280" y="4080240"/>
                <a:ext cx="1299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GAPDH 36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44" name="文本框 48"/>
          <p:cNvSpPr/>
          <p:nvPr/>
        </p:nvSpPr>
        <p:spPr>
          <a:xfrm>
            <a:off x="4657680" y="28440"/>
            <a:ext cx="221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0  L/I  M8I(5 10 20 40)n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5" name="组合 17"/>
          <p:cNvGrpSpPr/>
          <p:nvPr/>
        </p:nvGrpSpPr>
        <p:grpSpPr>
          <a:xfrm>
            <a:off x="4356000" y="231480"/>
            <a:ext cx="4651560" cy="1298520"/>
            <a:chOff x="4356000" y="231480"/>
            <a:chExt cx="4651560" cy="1298520"/>
          </a:xfrm>
        </p:grpSpPr>
        <p:grpSp>
          <p:nvGrpSpPr>
            <p:cNvPr id="146" name="组合 13"/>
            <p:cNvGrpSpPr/>
            <p:nvPr/>
          </p:nvGrpSpPr>
          <p:grpSpPr>
            <a:xfrm>
              <a:off x="4646520" y="305640"/>
              <a:ext cx="4361040" cy="1080000"/>
              <a:chOff x="4646520" y="305640"/>
              <a:chExt cx="4361040" cy="1080000"/>
            </a:xfrm>
          </p:grpSpPr>
          <p:pic>
            <p:nvPicPr>
              <p:cNvPr id="147" name="图片 1" descr="CD861-1"/>
              <p:cNvPicPr/>
              <p:nvPr/>
            </p:nvPicPr>
            <p:blipFill>
              <a:blip r:embed="rId10"/>
              <a:srcRect l="698347" t="387205" r="531405" b="912795"/>
              <a:stretch/>
            </p:blipFill>
            <p:spPr>
              <a:xfrm>
                <a:off x="7597440" y="305640"/>
                <a:ext cx="1410120" cy="1078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8" name="图片 2" descr="CD862-1"/>
              <p:cNvPicPr/>
              <p:nvPr/>
            </p:nvPicPr>
            <p:blipFill>
              <a:blip r:embed="rId11"/>
              <a:srcRect l="789744" t="319861" r="391168" b="945296"/>
              <a:stretch/>
            </p:blipFill>
            <p:spPr>
              <a:xfrm>
                <a:off x="4646520" y="306720"/>
                <a:ext cx="1424160" cy="1078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9" name="图片 3" descr="CD863-1"/>
              <p:cNvPicPr/>
              <p:nvPr/>
            </p:nvPicPr>
            <p:blipFill>
              <a:blip r:embed="rId12"/>
              <a:srcRect l="654545" t="318750" r="542045" b="950000"/>
              <a:stretch/>
            </p:blipFill>
            <p:spPr>
              <a:xfrm>
                <a:off x="6128640" y="305640"/>
                <a:ext cx="1410120" cy="10789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50" name="文本框 5"/>
            <p:cNvSpPr/>
            <p:nvPr/>
          </p:nvSpPr>
          <p:spPr>
            <a:xfrm rot="16200000">
              <a:off x="3844800" y="742320"/>
              <a:ext cx="129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D86 75K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1" name="组合 16"/>
          <p:cNvGrpSpPr/>
          <p:nvPr/>
        </p:nvGrpSpPr>
        <p:grpSpPr>
          <a:xfrm>
            <a:off x="4367160" y="1485720"/>
            <a:ext cx="4641840" cy="1298520"/>
            <a:chOff x="4367160" y="1485720"/>
            <a:chExt cx="4641840" cy="1298520"/>
          </a:xfrm>
        </p:grpSpPr>
        <p:pic>
          <p:nvPicPr>
            <p:cNvPr id="152" name="图片 7" descr="GAPDH5-1"/>
            <p:cNvPicPr/>
            <p:nvPr/>
          </p:nvPicPr>
          <p:blipFill>
            <a:blip r:embed="rId13"/>
            <a:srcRect l="811014" t="495745" r="362319" b="751773"/>
            <a:stretch/>
          </p:blipFill>
          <p:spPr>
            <a:xfrm>
              <a:off x="4646160" y="1563840"/>
              <a:ext cx="1409760" cy="107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3" name="图片 8" descr="GAPDH4-1"/>
            <p:cNvPicPr/>
            <p:nvPr/>
          </p:nvPicPr>
          <p:blipFill>
            <a:blip r:embed="rId14"/>
            <a:srcRect l="753333" t="504610" r="420290" b="742908"/>
            <a:stretch/>
          </p:blipFill>
          <p:spPr>
            <a:xfrm>
              <a:off x="6122520" y="1563840"/>
              <a:ext cx="1409760" cy="107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4" name="图片 9" descr="GAPDH3-1"/>
            <p:cNvPicPr/>
            <p:nvPr/>
          </p:nvPicPr>
          <p:blipFill>
            <a:blip r:embed="rId15"/>
            <a:srcRect l="753043" t="353546" r="420580" b="893972"/>
            <a:stretch/>
          </p:blipFill>
          <p:spPr>
            <a:xfrm>
              <a:off x="7599240" y="1563840"/>
              <a:ext cx="1409760" cy="107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5" name="文本框 18"/>
            <p:cNvSpPr/>
            <p:nvPr/>
          </p:nvSpPr>
          <p:spPr>
            <a:xfrm rot="16200000">
              <a:off x="3855960" y="1996560"/>
              <a:ext cx="129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GAPDH 36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6" name="组合 37"/>
          <p:cNvGrpSpPr/>
          <p:nvPr/>
        </p:nvGrpSpPr>
        <p:grpSpPr>
          <a:xfrm>
            <a:off x="297000" y="5346720"/>
            <a:ext cx="3810960" cy="1490760"/>
            <a:chOff x="297000" y="5346720"/>
            <a:chExt cx="3810960" cy="1490760"/>
          </a:xfrm>
        </p:grpSpPr>
        <p:pic>
          <p:nvPicPr>
            <p:cNvPr id="157" name="图片 35" descr="gapdh3-1"/>
            <p:cNvPicPr/>
            <p:nvPr/>
          </p:nvPicPr>
          <p:blipFill>
            <a:blip r:embed="rId1"/>
            <a:srcRect l="998313" t="281471" r="619759" b="808529"/>
            <a:stretch/>
          </p:blipFill>
          <p:spPr>
            <a:xfrm>
              <a:off x="567360" y="5346720"/>
              <a:ext cx="1032120" cy="149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8" name="图片 34" descr="gapdh2-1"/>
            <p:cNvPicPr/>
            <p:nvPr/>
          </p:nvPicPr>
          <p:blipFill>
            <a:blip r:embed="rId2"/>
            <a:srcRect l="974588" t="823851" r="659765" b="294828"/>
            <a:stretch/>
          </p:blipFill>
          <p:spPr>
            <a:xfrm>
              <a:off x="3076200" y="5346720"/>
              <a:ext cx="1031760" cy="149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9" name="图片 33" descr="gapdh1-1"/>
            <p:cNvPicPr/>
            <p:nvPr/>
          </p:nvPicPr>
          <p:blipFill>
            <a:blip r:embed="rId3"/>
            <a:srcRect l="929440" t="317507" r="681995" b="760831"/>
            <a:stretch/>
          </p:blipFill>
          <p:spPr>
            <a:xfrm>
              <a:off x="1821600" y="5346720"/>
              <a:ext cx="1032120" cy="149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0" name="文本框 36"/>
            <p:cNvSpPr/>
            <p:nvPr/>
          </p:nvSpPr>
          <p:spPr>
            <a:xfrm rot="16200000">
              <a:off x="-214560" y="5949360"/>
              <a:ext cx="13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GAPDH 36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1" name="组合 42"/>
          <p:cNvGrpSpPr/>
          <p:nvPr/>
        </p:nvGrpSpPr>
        <p:grpSpPr>
          <a:xfrm>
            <a:off x="297000" y="3778200"/>
            <a:ext cx="3811320" cy="1488960"/>
            <a:chOff x="297000" y="3778200"/>
            <a:chExt cx="3811320" cy="1488960"/>
          </a:xfrm>
        </p:grpSpPr>
        <p:pic>
          <p:nvPicPr>
            <p:cNvPr id="162" name="图片 39" descr="PPAR2-1"/>
            <p:cNvPicPr/>
            <p:nvPr/>
          </p:nvPicPr>
          <p:blipFill>
            <a:blip r:embed="rId4"/>
            <a:srcRect l="939312" t="191291" r="666093" b="875075"/>
            <a:stretch/>
          </p:blipFill>
          <p:spPr>
            <a:xfrm>
              <a:off x="3078360" y="3778200"/>
              <a:ext cx="1029960" cy="1488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3" name="图片 40" descr="PPAR3-1"/>
            <p:cNvPicPr/>
            <p:nvPr/>
          </p:nvPicPr>
          <p:blipFill>
            <a:blip r:embed="rId5"/>
            <a:srcRect l="890676" t="271795" r="751282" b="858974"/>
            <a:stretch/>
          </p:blipFill>
          <p:spPr>
            <a:xfrm>
              <a:off x="1827360" y="3778200"/>
              <a:ext cx="1029960" cy="1488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4" name="图片 38" descr="PPAR1-1"/>
            <p:cNvPicPr/>
            <p:nvPr/>
          </p:nvPicPr>
          <p:blipFill>
            <a:blip r:embed="rId6"/>
            <a:srcRect l="181250" t="50273" r="118824" b="155455"/>
            <a:stretch/>
          </p:blipFill>
          <p:spPr>
            <a:xfrm>
              <a:off x="576720" y="3778200"/>
              <a:ext cx="1029960" cy="1488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5" name="文本框 41"/>
            <p:cNvSpPr/>
            <p:nvPr/>
          </p:nvSpPr>
          <p:spPr>
            <a:xfrm rot="16200000">
              <a:off x="-213840" y="4379400"/>
              <a:ext cx="129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PARG 58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6" name="文本框 43"/>
          <p:cNvSpPr/>
          <p:nvPr/>
        </p:nvSpPr>
        <p:spPr>
          <a:xfrm>
            <a:off x="573120" y="3489480"/>
            <a:ext cx="221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OE-EV+L/I  OE-MMP8+L/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7" name="组合 53"/>
          <p:cNvGrpSpPr/>
          <p:nvPr/>
        </p:nvGrpSpPr>
        <p:grpSpPr>
          <a:xfrm>
            <a:off x="297000" y="303120"/>
            <a:ext cx="3811320" cy="1490760"/>
            <a:chOff x="297000" y="303120"/>
            <a:chExt cx="3811320" cy="1490760"/>
          </a:xfrm>
        </p:grpSpPr>
        <p:pic>
          <p:nvPicPr>
            <p:cNvPr id="168" name="图片 52" descr="CO-GPP"/>
            <p:cNvPicPr/>
            <p:nvPr/>
          </p:nvPicPr>
          <p:blipFill>
            <a:blip r:embed="rId7"/>
            <a:srcRect l="919778" t="274526" r="753111" b="911111"/>
            <a:stretch/>
          </p:blipFill>
          <p:spPr>
            <a:xfrm>
              <a:off x="1827720" y="303120"/>
              <a:ext cx="1030320" cy="149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9" name="图片 44" descr="ppar1-1"/>
            <p:cNvPicPr/>
            <p:nvPr/>
          </p:nvPicPr>
          <p:blipFill>
            <a:blip r:embed="rId8"/>
            <a:srcRect l="992326" t="372807" r="629496" b="723977"/>
            <a:stretch/>
          </p:blipFill>
          <p:spPr>
            <a:xfrm>
              <a:off x="576000" y="303120"/>
              <a:ext cx="1031400" cy="149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0" name="图片 45" descr="ppar2-1"/>
            <p:cNvPicPr/>
            <p:nvPr/>
          </p:nvPicPr>
          <p:blipFill>
            <a:blip r:embed="rId9"/>
            <a:srcRect l="938821" t="286787" r="666339" b="779279"/>
            <a:stretch/>
          </p:blipFill>
          <p:spPr>
            <a:xfrm>
              <a:off x="3078000" y="303120"/>
              <a:ext cx="1030320" cy="149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1" name="文本框 46"/>
            <p:cNvSpPr/>
            <p:nvPr/>
          </p:nvSpPr>
          <p:spPr>
            <a:xfrm rot="16200000">
              <a:off x="-214560" y="906480"/>
              <a:ext cx="1300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PARG 58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2" name="文本框 48"/>
          <p:cNvSpPr/>
          <p:nvPr/>
        </p:nvSpPr>
        <p:spPr>
          <a:xfrm>
            <a:off x="568440" y="28440"/>
            <a:ext cx="221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L/I  M8I+L/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3" name="组合 2"/>
          <p:cNvGrpSpPr/>
          <p:nvPr/>
        </p:nvGrpSpPr>
        <p:grpSpPr>
          <a:xfrm>
            <a:off x="298440" y="1874880"/>
            <a:ext cx="3812760" cy="1490760"/>
            <a:chOff x="298440" y="1874880"/>
            <a:chExt cx="3812760" cy="1490760"/>
          </a:xfrm>
        </p:grpSpPr>
        <p:pic>
          <p:nvPicPr>
            <p:cNvPr id="174" name="图片 1" descr="2-GAPDH-5-1"/>
            <p:cNvPicPr/>
            <p:nvPr/>
          </p:nvPicPr>
          <p:blipFill>
            <a:blip r:embed="rId10"/>
            <a:srcRect l="811735" t="261682" r="766582" b="757632"/>
            <a:stretch/>
          </p:blipFill>
          <p:spPr>
            <a:xfrm>
              <a:off x="3080160" y="1874880"/>
              <a:ext cx="1031040" cy="1490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75" name="组合 57"/>
            <p:cNvGrpSpPr/>
            <p:nvPr/>
          </p:nvGrpSpPr>
          <p:grpSpPr>
            <a:xfrm>
              <a:off x="298440" y="1874880"/>
              <a:ext cx="2556360" cy="1490760"/>
              <a:chOff x="298440" y="1874880"/>
              <a:chExt cx="2556360" cy="1490760"/>
            </a:xfrm>
          </p:grpSpPr>
          <p:pic>
            <p:nvPicPr>
              <p:cNvPr id="176" name="图片 54" descr="gapdh3-1"/>
              <p:cNvPicPr/>
              <p:nvPr/>
            </p:nvPicPr>
            <p:blipFill>
              <a:blip r:embed="rId11"/>
              <a:srcRect l="999758" t="482301" r="617150" b="605605"/>
              <a:stretch/>
            </p:blipFill>
            <p:spPr>
              <a:xfrm>
                <a:off x="577800" y="1874880"/>
                <a:ext cx="1030320" cy="1490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7" name="图片 51" descr="CO-GAPDH"/>
              <p:cNvPicPr/>
              <p:nvPr/>
            </p:nvPicPr>
            <p:blipFill>
              <a:blip r:embed="rId12"/>
              <a:srcRect l="920000" t="432249" r="752000" b="753388"/>
              <a:stretch/>
            </p:blipFill>
            <p:spPr>
              <a:xfrm>
                <a:off x="1824480" y="1874880"/>
                <a:ext cx="1030320" cy="1490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8" name="文本框 55"/>
              <p:cNvSpPr/>
              <p:nvPr/>
            </p:nvSpPr>
            <p:spPr>
              <a:xfrm rot="16200000">
                <a:off x="-213120" y="2478240"/>
                <a:ext cx="1300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GAPDH 36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79" name="组合 55"/>
          <p:cNvGrpSpPr/>
          <p:nvPr/>
        </p:nvGrpSpPr>
        <p:grpSpPr>
          <a:xfrm>
            <a:off x="4741920" y="0"/>
            <a:ext cx="3838680" cy="4890600"/>
            <a:chOff x="4741920" y="0"/>
            <a:chExt cx="3838680" cy="4890600"/>
          </a:xfrm>
        </p:grpSpPr>
        <p:grpSp>
          <p:nvGrpSpPr>
            <p:cNvPr id="180" name="组合 28"/>
            <p:cNvGrpSpPr/>
            <p:nvPr/>
          </p:nvGrpSpPr>
          <p:grpSpPr>
            <a:xfrm>
              <a:off x="4742280" y="3400560"/>
              <a:ext cx="3838320" cy="1490040"/>
              <a:chOff x="4742280" y="3400560"/>
              <a:chExt cx="3838320" cy="1490040"/>
            </a:xfrm>
          </p:grpSpPr>
          <p:pic>
            <p:nvPicPr>
              <p:cNvPr id="181" name="图片 26" descr="GAPDH3-1"/>
              <p:cNvPicPr/>
              <p:nvPr/>
            </p:nvPicPr>
            <p:blipFill>
              <a:blip r:embed="rId13"/>
              <a:srcRect l="907160" t="276744" r="722434" b="827326"/>
              <a:stretch/>
            </p:blipFill>
            <p:spPr>
              <a:xfrm>
                <a:off x="7555320" y="3400560"/>
                <a:ext cx="102528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2" name="图片 25" descr="GAPDH2-1"/>
              <p:cNvPicPr/>
              <p:nvPr/>
            </p:nvPicPr>
            <p:blipFill>
              <a:blip r:embed="rId14"/>
              <a:srcRect l="818970" t="455429" r="819672" b="670000"/>
              <a:stretch/>
            </p:blipFill>
            <p:spPr>
              <a:xfrm>
                <a:off x="6296040" y="3400560"/>
                <a:ext cx="102960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3" name="图片 24" descr="GAPDH1-1"/>
              <p:cNvPicPr/>
              <p:nvPr/>
            </p:nvPicPr>
            <p:blipFill>
              <a:blip r:embed="rId15"/>
              <a:srcRect l="992530" t="279706" r="630120" b="812059"/>
              <a:stretch/>
            </p:blipFill>
            <p:spPr>
              <a:xfrm>
                <a:off x="5040720" y="3400560"/>
                <a:ext cx="1025640" cy="1490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4" name="文本框 27"/>
              <p:cNvSpPr/>
              <p:nvPr/>
            </p:nvSpPr>
            <p:spPr>
              <a:xfrm rot="16200000">
                <a:off x="4230720" y="4003920"/>
                <a:ext cx="1299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GAPDH 36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5" name="组合 17"/>
            <p:cNvGrpSpPr/>
            <p:nvPr/>
          </p:nvGrpSpPr>
          <p:grpSpPr>
            <a:xfrm>
              <a:off x="4741920" y="275400"/>
              <a:ext cx="3824640" cy="1490040"/>
              <a:chOff x="4741920" y="275400"/>
              <a:chExt cx="3824640" cy="1490040"/>
            </a:xfrm>
          </p:grpSpPr>
          <p:pic>
            <p:nvPicPr>
              <p:cNvPr id="186" name="图片 15" descr="110-140-2-1"/>
              <p:cNvPicPr/>
              <p:nvPr/>
            </p:nvPicPr>
            <p:blipFill>
              <a:blip r:embed="rId16"/>
              <a:srcRect l="804946" t="334646" r="888817" b="887664"/>
              <a:stretch/>
            </p:blipFill>
            <p:spPr>
              <a:xfrm>
                <a:off x="6284880" y="275400"/>
                <a:ext cx="103068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7" name="图片 16" descr="110-140-3-1"/>
              <p:cNvPicPr/>
              <p:nvPr/>
            </p:nvPicPr>
            <p:blipFill>
              <a:blip r:embed="rId17"/>
              <a:srcRect l="966094" t="250262" r="728755" b="974346"/>
              <a:stretch/>
            </p:blipFill>
            <p:spPr>
              <a:xfrm>
                <a:off x="7535880" y="275400"/>
                <a:ext cx="103068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8" name="图片 14" descr="110-140-1-1"/>
              <p:cNvPicPr/>
              <p:nvPr/>
            </p:nvPicPr>
            <p:blipFill>
              <a:blip r:embed="rId18"/>
              <a:srcRect l="1073319" t="367949" r="635084" b="880256"/>
              <a:stretch/>
            </p:blipFill>
            <p:spPr>
              <a:xfrm>
                <a:off x="5033520" y="275400"/>
                <a:ext cx="1030680" cy="1490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9" name="文本框 13"/>
              <p:cNvSpPr/>
              <p:nvPr/>
            </p:nvSpPr>
            <p:spPr>
              <a:xfrm rot="16200000">
                <a:off x="4230360" y="878040"/>
                <a:ext cx="1299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iNOS 131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0" name="组合 23"/>
            <p:cNvGrpSpPr/>
            <p:nvPr/>
          </p:nvGrpSpPr>
          <p:grpSpPr>
            <a:xfrm>
              <a:off x="4741920" y="1838160"/>
              <a:ext cx="3838680" cy="1490040"/>
              <a:chOff x="4741920" y="1838160"/>
              <a:chExt cx="3838680" cy="1490040"/>
            </a:xfrm>
          </p:grpSpPr>
          <p:pic>
            <p:nvPicPr>
              <p:cNvPr id="191" name="图片 21" descr="CD863-1"/>
              <p:cNvPicPr/>
              <p:nvPr/>
            </p:nvPicPr>
            <p:blipFill>
              <a:blip r:embed="rId19"/>
              <a:srcRect l="927184" t="188131" r="686650" b="894065"/>
              <a:stretch/>
            </p:blipFill>
            <p:spPr>
              <a:xfrm>
                <a:off x="6301080" y="1838160"/>
                <a:ext cx="103032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2" name="图片 20" descr="CD862-1"/>
              <p:cNvPicPr/>
              <p:nvPr/>
            </p:nvPicPr>
            <p:blipFill>
              <a:blip r:embed="rId20"/>
              <a:srcRect l="990191" t="278947" r="634211" b="820760"/>
              <a:stretch/>
            </p:blipFill>
            <p:spPr>
              <a:xfrm>
                <a:off x="7551000" y="1838160"/>
                <a:ext cx="102960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3" name="图片 19" descr="CD861-1"/>
              <p:cNvPicPr/>
              <p:nvPr/>
            </p:nvPicPr>
            <p:blipFill>
              <a:blip r:embed="rId21"/>
              <a:srcRect l="974235" t="297508" r="604337" b="722430"/>
              <a:stretch/>
            </p:blipFill>
            <p:spPr>
              <a:xfrm>
                <a:off x="5050440" y="1838160"/>
                <a:ext cx="1031040" cy="1490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94" name="文本框 22"/>
              <p:cNvSpPr/>
              <p:nvPr/>
            </p:nvSpPr>
            <p:spPr>
              <a:xfrm rot="16200000">
                <a:off x="4230360" y="2440440"/>
                <a:ext cx="1299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CD86 75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5" name="文本框 31"/>
            <p:cNvSpPr/>
            <p:nvPr/>
          </p:nvSpPr>
          <p:spPr>
            <a:xfrm>
              <a:off x="5083200" y="0"/>
              <a:ext cx="3001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/I  M8I+L/I GW9662+M8I+L/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文本框 52"/>
          <p:cNvSpPr/>
          <p:nvPr/>
        </p:nvSpPr>
        <p:spPr>
          <a:xfrm>
            <a:off x="7380360" y="65160"/>
            <a:ext cx="1460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I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input  igG  PPAR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7" name="组合 54"/>
          <p:cNvGrpSpPr/>
          <p:nvPr/>
        </p:nvGrpSpPr>
        <p:grpSpPr>
          <a:xfrm>
            <a:off x="174600" y="44280"/>
            <a:ext cx="3860640" cy="3282840"/>
            <a:chOff x="174600" y="44280"/>
            <a:chExt cx="3860640" cy="3282840"/>
          </a:xfrm>
        </p:grpSpPr>
        <p:grpSp>
          <p:nvGrpSpPr>
            <p:cNvPr id="198" name="组合 35"/>
            <p:cNvGrpSpPr/>
            <p:nvPr/>
          </p:nvGrpSpPr>
          <p:grpSpPr>
            <a:xfrm>
              <a:off x="174960" y="1837800"/>
              <a:ext cx="3860280" cy="1489320"/>
              <a:chOff x="174960" y="1837800"/>
              <a:chExt cx="3860280" cy="1489320"/>
            </a:xfrm>
          </p:grpSpPr>
          <p:pic>
            <p:nvPicPr>
              <p:cNvPr id="199" name="图片 6" descr="2-GAPDH-1-1"/>
              <p:cNvPicPr/>
              <p:nvPr/>
            </p:nvPicPr>
            <p:blipFill>
              <a:blip r:embed="rId1"/>
              <a:srcRect l="893367" t="297508" r="685714" b="722430"/>
              <a:stretch/>
            </p:blipFill>
            <p:spPr>
              <a:xfrm>
                <a:off x="1747440" y="1837800"/>
                <a:ext cx="1029960" cy="1489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0" name="图片 30" descr="2-GAPDH-2-1"/>
              <p:cNvPicPr/>
              <p:nvPr/>
            </p:nvPicPr>
            <p:blipFill>
              <a:blip r:embed="rId2"/>
              <a:srcRect l="974235" t="297508" r="604847" b="722430"/>
              <a:stretch/>
            </p:blipFill>
            <p:spPr>
              <a:xfrm>
                <a:off x="489240" y="1837800"/>
                <a:ext cx="1029960" cy="1489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1" name="图片 33" descr="2-GAPDH-3-1"/>
              <p:cNvPicPr/>
              <p:nvPr/>
            </p:nvPicPr>
            <p:blipFill>
              <a:blip r:embed="rId3"/>
              <a:srcRect l="893367" t="297508" r="685714" b="722430"/>
              <a:stretch/>
            </p:blipFill>
            <p:spPr>
              <a:xfrm>
                <a:off x="3005280" y="1837800"/>
                <a:ext cx="1029960" cy="1489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2" name="文本框 34"/>
              <p:cNvSpPr/>
              <p:nvPr/>
            </p:nvSpPr>
            <p:spPr>
              <a:xfrm rot="16200000">
                <a:off x="-335880" y="2439000"/>
                <a:ext cx="1298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GAPDH 36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3" name="组合 39"/>
            <p:cNvGrpSpPr/>
            <p:nvPr/>
          </p:nvGrpSpPr>
          <p:grpSpPr>
            <a:xfrm>
              <a:off x="174600" y="275040"/>
              <a:ext cx="3860640" cy="1490040"/>
              <a:chOff x="174600" y="275040"/>
              <a:chExt cx="3860640" cy="1490040"/>
            </a:xfrm>
          </p:grpSpPr>
          <p:pic>
            <p:nvPicPr>
              <p:cNvPr id="204" name="图片 36" descr="2-MMP-1-1"/>
              <p:cNvPicPr/>
              <p:nvPr/>
            </p:nvPicPr>
            <p:blipFill>
              <a:blip r:embed="rId4"/>
              <a:srcRect l="847343" t="376696" r="769324" b="710029"/>
              <a:stretch/>
            </p:blipFill>
            <p:spPr>
              <a:xfrm>
                <a:off x="3005280" y="275040"/>
                <a:ext cx="102996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5" name="图片 37" descr="2-MMP-2-1"/>
              <p:cNvPicPr/>
              <p:nvPr/>
            </p:nvPicPr>
            <p:blipFill>
              <a:blip r:embed="rId5"/>
              <a:srcRect l="898368" t="453561" r="743124" b="676638"/>
              <a:stretch/>
            </p:blipFill>
            <p:spPr>
              <a:xfrm>
                <a:off x="1747440" y="275040"/>
                <a:ext cx="1029960" cy="149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6" name="图片 38" descr="2-MMP-3-1"/>
              <p:cNvPicPr/>
              <p:nvPr/>
            </p:nvPicPr>
            <p:blipFill>
              <a:blip r:embed="rId6"/>
              <a:srcRect l="896714" t="365616" r="740610" b="757020"/>
              <a:stretch/>
            </p:blipFill>
            <p:spPr>
              <a:xfrm>
                <a:off x="489600" y="275040"/>
                <a:ext cx="1029960" cy="1490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7" name="文本框 41"/>
              <p:cNvSpPr/>
              <p:nvPr/>
            </p:nvSpPr>
            <p:spPr>
              <a:xfrm rot="16200000">
                <a:off x="-336600" y="877320"/>
                <a:ext cx="1299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MMP8 55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8" name="文本框 40"/>
            <p:cNvSpPr/>
            <p:nvPr/>
          </p:nvSpPr>
          <p:spPr>
            <a:xfrm>
              <a:off x="486000" y="44280"/>
              <a:ext cx="3001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OE-EV  OE-MMP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9" name="组合 53"/>
          <p:cNvGrpSpPr/>
          <p:nvPr/>
        </p:nvGrpSpPr>
        <p:grpSpPr>
          <a:xfrm>
            <a:off x="174600" y="3441600"/>
            <a:ext cx="3861000" cy="3349440"/>
            <a:chOff x="174600" y="3441600"/>
            <a:chExt cx="3861000" cy="3349440"/>
          </a:xfrm>
        </p:grpSpPr>
        <p:grpSp>
          <p:nvGrpSpPr>
            <p:cNvPr id="210" name="组合 46"/>
            <p:cNvGrpSpPr/>
            <p:nvPr/>
          </p:nvGrpSpPr>
          <p:grpSpPr>
            <a:xfrm>
              <a:off x="178200" y="3717000"/>
              <a:ext cx="3856680" cy="1489680"/>
              <a:chOff x="178200" y="3717000"/>
              <a:chExt cx="3856680" cy="1489680"/>
            </a:xfrm>
          </p:grpSpPr>
          <p:pic>
            <p:nvPicPr>
              <p:cNvPr id="211" name="图片 42" descr="CD86-1-1"/>
              <p:cNvPicPr/>
              <p:nvPr/>
            </p:nvPicPr>
            <p:blipFill>
              <a:blip r:embed="rId7"/>
              <a:srcRect l="878802" t="386798" r="771429" b="758708"/>
              <a:stretch/>
            </p:blipFill>
            <p:spPr>
              <a:xfrm>
                <a:off x="1747080" y="3717000"/>
                <a:ext cx="1029600" cy="1489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2" name="图片 43" descr="CD86-2-1"/>
              <p:cNvPicPr/>
              <p:nvPr/>
            </p:nvPicPr>
            <p:blipFill>
              <a:blip r:embed="rId8"/>
              <a:srcRect l="877241" t="296348" r="773563" b="851124"/>
              <a:stretch/>
            </p:blipFill>
            <p:spPr>
              <a:xfrm>
                <a:off x="3004560" y="3717000"/>
                <a:ext cx="1030320" cy="1489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3" name="图片 44" descr="CD86-4-1"/>
              <p:cNvPicPr/>
              <p:nvPr/>
            </p:nvPicPr>
            <p:blipFill>
              <a:blip r:embed="rId9"/>
              <a:srcRect l="846336" t="194474" r="845259" b="1025263"/>
              <a:stretch/>
            </p:blipFill>
            <p:spPr>
              <a:xfrm>
                <a:off x="488880" y="3717000"/>
                <a:ext cx="1030320" cy="1489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4" name="文本框 45"/>
              <p:cNvSpPr/>
              <p:nvPr/>
            </p:nvSpPr>
            <p:spPr>
              <a:xfrm rot="16200000">
                <a:off x="-333000" y="4318560"/>
                <a:ext cx="1299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CD86 75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5" name="组合 51"/>
            <p:cNvGrpSpPr/>
            <p:nvPr/>
          </p:nvGrpSpPr>
          <p:grpSpPr>
            <a:xfrm>
              <a:off x="174600" y="5301360"/>
              <a:ext cx="3860640" cy="1489680"/>
              <a:chOff x="174600" y="5301360"/>
              <a:chExt cx="3860640" cy="1489680"/>
            </a:xfrm>
          </p:grpSpPr>
          <p:pic>
            <p:nvPicPr>
              <p:cNvPr id="216" name="图片 47" descr="GAPDH3-1"/>
              <p:cNvPicPr/>
              <p:nvPr/>
            </p:nvPicPr>
            <p:blipFill>
              <a:blip r:embed="rId10"/>
              <a:srcRect l="895610" t="188988" r="715610" b="888095"/>
              <a:stretch/>
            </p:blipFill>
            <p:spPr>
              <a:xfrm>
                <a:off x="3005640" y="5301360"/>
                <a:ext cx="1029600" cy="1489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7" name="图片 48" descr="GAPDH4-1"/>
              <p:cNvPicPr/>
              <p:nvPr/>
            </p:nvPicPr>
            <p:blipFill>
              <a:blip r:embed="rId11"/>
              <a:srcRect l="855990" t="189552" r="753056" b="883284"/>
              <a:stretch/>
            </p:blipFill>
            <p:spPr>
              <a:xfrm>
                <a:off x="1746720" y="5301360"/>
                <a:ext cx="1029600" cy="1489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8" name="图片 49" descr="GAPDH5-1用"/>
              <p:cNvPicPr/>
              <p:nvPr/>
            </p:nvPicPr>
            <p:blipFill>
              <a:blip r:embed="rId12"/>
              <a:srcRect l="887778" t="259079" r="785333" b="926829"/>
              <a:stretch/>
            </p:blipFill>
            <p:spPr>
              <a:xfrm>
                <a:off x="488160" y="5301360"/>
                <a:ext cx="1029600" cy="1489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9" name="文本框 50"/>
              <p:cNvSpPr/>
              <p:nvPr/>
            </p:nvSpPr>
            <p:spPr>
              <a:xfrm rot="16200000">
                <a:off x="-336600" y="5902920"/>
                <a:ext cx="1299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GAPDH 36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0" name="文本框 52"/>
            <p:cNvSpPr/>
            <p:nvPr/>
          </p:nvSpPr>
          <p:spPr>
            <a:xfrm>
              <a:off x="486720" y="3441600"/>
              <a:ext cx="354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/I  OE-MMP8+L/I  GW1929+OE-MMP8+L/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1" name="组合 12"/>
          <p:cNvGrpSpPr/>
          <p:nvPr/>
        </p:nvGrpSpPr>
        <p:grpSpPr>
          <a:xfrm>
            <a:off x="4929120" y="65160"/>
            <a:ext cx="2111400" cy="6035760"/>
            <a:chOff x="4929120" y="65160"/>
            <a:chExt cx="2111400" cy="6035760"/>
          </a:xfrm>
        </p:grpSpPr>
        <p:sp>
          <p:nvSpPr>
            <p:cNvPr id="222" name="文本框 52"/>
            <p:cNvSpPr/>
            <p:nvPr/>
          </p:nvSpPr>
          <p:spPr>
            <a:xfrm>
              <a:off x="5508000" y="65160"/>
              <a:ext cx="14598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       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I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input  igG  MMP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3" name="组合 5"/>
            <p:cNvGrpSpPr/>
            <p:nvPr/>
          </p:nvGrpSpPr>
          <p:grpSpPr>
            <a:xfrm>
              <a:off x="4929120" y="547200"/>
              <a:ext cx="2111400" cy="5553720"/>
              <a:chOff x="4929120" y="547200"/>
              <a:chExt cx="2111400" cy="5553720"/>
            </a:xfrm>
          </p:grpSpPr>
          <p:pic>
            <p:nvPicPr>
              <p:cNvPr id="224" name="图片 1" descr="MM-GAPDH-1-1"/>
              <p:cNvPicPr/>
              <p:nvPr/>
            </p:nvPicPr>
            <p:blipFill>
              <a:blip r:embed="rId13"/>
              <a:srcRect l="32909" t="25859" r="21025" b="31054"/>
              <a:stretch/>
            </p:blipFill>
            <p:spPr>
              <a:xfrm>
                <a:off x="4929840" y="4485240"/>
                <a:ext cx="2110680" cy="1615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5" name="图片 2" descr="MM-MM-3-1"/>
              <p:cNvPicPr/>
              <p:nvPr/>
            </p:nvPicPr>
            <p:blipFill>
              <a:blip r:embed="rId14"/>
              <a:srcRect l="29946" t="16908" r="24923" b="40887"/>
              <a:stretch/>
            </p:blipFill>
            <p:spPr>
              <a:xfrm>
                <a:off x="4929840" y="2514960"/>
                <a:ext cx="2110680" cy="1615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6" name="图片 3" descr="MM-PP-3-1"/>
              <p:cNvPicPr/>
              <p:nvPr/>
            </p:nvPicPr>
            <p:blipFill>
              <a:blip r:embed="rId15"/>
              <a:srcRect l="32612" t="13678" r="21738" b="43651"/>
              <a:stretch/>
            </p:blipFill>
            <p:spPr>
              <a:xfrm>
                <a:off x="4929120" y="547200"/>
                <a:ext cx="2110680" cy="161460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grpSp>
        <p:nvGrpSpPr>
          <p:cNvPr id="227" name="组合 11"/>
          <p:cNvGrpSpPr/>
          <p:nvPr/>
        </p:nvGrpSpPr>
        <p:grpSpPr>
          <a:xfrm>
            <a:off x="7273800" y="561960"/>
            <a:ext cx="1397160" cy="5553000"/>
            <a:chOff x="7273800" y="561960"/>
            <a:chExt cx="1397160" cy="5553000"/>
          </a:xfrm>
        </p:grpSpPr>
        <p:pic>
          <p:nvPicPr>
            <p:cNvPr id="228" name="图片 7" descr="Input-GAPDH"/>
            <p:cNvPicPr/>
            <p:nvPr/>
          </p:nvPicPr>
          <p:blipFill>
            <a:blip r:embed="rId16"/>
            <a:stretch/>
          </p:blipFill>
          <p:spPr>
            <a:xfrm>
              <a:off x="7417080" y="4454280"/>
              <a:ext cx="969840" cy="166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9" name="图片 8" descr="MMP8"/>
            <p:cNvPicPr/>
            <p:nvPr/>
          </p:nvPicPr>
          <p:blipFill>
            <a:blip r:embed="rId17"/>
            <a:srcRect l="315789" t="0" r="0" b="0"/>
            <a:stretch/>
          </p:blipFill>
          <p:spPr>
            <a:xfrm>
              <a:off x="7308000" y="2511000"/>
              <a:ext cx="1362960" cy="160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0" name="图片 9" descr="PPARG"/>
            <p:cNvPicPr/>
            <p:nvPr/>
          </p:nvPicPr>
          <p:blipFill>
            <a:blip r:embed="rId18"/>
            <a:stretch/>
          </p:blipFill>
          <p:spPr>
            <a:xfrm>
              <a:off x="7273800" y="561960"/>
              <a:ext cx="1359720" cy="16117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31" name="文本框 34"/>
          <p:cNvSpPr/>
          <p:nvPr/>
        </p:nvSpPr>
        <p:spPr>
          <a:xfrm rot="16200000">
            <a:off x="4143240" y="5214240"/>
            <a:ext cx="129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GAPDH 36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文本框 41"/>
          <p:cNvSpPr/>
          <p:nvPr/>
        </p:nvSpPr>
        <p:spPr>
          <a:xfrm rot="16200000">
            <a:off x="4142520" y="3221640"/>
            <a:ext cx="13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MP8 55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文本框 41"/>
          <p:cNvSpPr/>
          <p:nvPr/>
        </p:nvSpPr>
        <p:spPr>
          <a:xfrm rot="16200000">
            <a:off x="4002480" y="1209600"/>
            <a:ext cx="155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PARG 50-58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文本框 41"/>
          <p:cNvSpPr/>
          <p:nvPr/>
        </p:nvSpPr>
        <p:spPr>
          <a:xfrm rot="16200000">
            <a:off x="3875760" y="3278880"/>
            <a:ext cx="13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I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直接连接符 17"/>
          <p:cNvSpPr/>
          <p:nvPr/>
        </p:nvSpPr>
        <p:spPr>
          <a:xfrm flipH="1">
            <a:off x="4645080" y="785880"/>
            <a:ext cx="1440" cy="4946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直接连接符 18"/>
          <p:cNvSpPr/>
          <p:nvPr/>
        </p:nvSpPr>
        <p:spPr>
          <a:xfrm flipH="1" flipV="1">
            <a:off x="6054840" y="274320"/>
            <a:ext cx="627120" cy="3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直接连接符 19"/>
          <p:cNvSpPr/>
          <p:nvPr/>
        </p:nvSpPr>
        <p:spPr>
          <a:xfrm flipH="1" flipV="1">
            <a:off x="7956360" y="274320"/>
            <a:ext cx="626760" cy="3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8" name="组合 4"/>
          <p:cNvGrpSpPr/>
          <p:nvPr/>
        </p:nvGrpSpPr>
        <p:grpSpPr>
          <a:xfrm>
            <a:off x="393840" y="65160"/>
            <a:ext cx="3641760" cy="6737400"/>
            <a:chOff x="393840" y="65160"/>
            <a:chExt cx="3641760" cy="6737400"/>
          </a:xfrm>
        </p:grpSpPr>
        <p:grpSp>
          <p:nvGrpSpPr>
            <p:cNvPr id="239" name="组合 3"/>
            <p:cNvGrpSpPr/>
            <p:nvPr/>
          </p:nvGrpSpPr>
          <p:grpSpPr>
            <a:xfrm>
              <a:off x="393840" y="2924280"/>
              <a:ext cx="3253320" cy="1266120"/>
              <a:chOff x="393840" y="2924280"/>
              <a:chExt cx="3253320" cy="1266120"/>
            </a:xfrm>
          </p:grpSpPr>
          <p:pic>
            <p:nvPicPr>
              <p:cNvPr id="240" name="图片 7" descr="caspase1-1"/>
              <p:cNvPicPr/>
              <p:nvPr/>
            </p:nvPicPr>
            <p:blipFill>
              <a:blip r:embed="rId1"/>
              <a:srcRect l="898841" t="287589" r="704348" b="775532"/>
              <a:stretch/>
            </p:blipFill>
            <p:spPr>
              <a:xfrm>
                <a:off x="629280" y="2924280"/>
                <a:ext cx="875880" cy="1266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1" name="图片 8" descr="caspase2-1"/>
              <p:cNvPicPr/>
              <p:nvPr/>
            </p:nvPicPr>
            <p:blipFill>
              <a:blip r:embed="rId2"/>
              <a:srcRect l="942029" t="291844" r="661159" b="770567"/>
              <a:stretch/>
            </p:blipFill>
            <p:spPr>
              <a:xfrm>
                <a:off x="1700280" y="2924280"/>
                <a:ext cx="875880" cy="1266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2" name="图片 9" descr="caspase4-1"/>
              <p:cNvPicPr/>
              <p:nvPr/>
            </p:nvPicPr>
            <p:blipFill>
              <a:blip r:embed="rId3"/>
              <a:srcRect l="994752" t="193214" r="604082" b="861429"/>
              <a:stretch/>
            </p:blipFill>
            <p:spPr>
              <a:xfrm>
                <a:off x="2771280" y="2924280"/>
                <a:ext cx="875880" cy="1266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43" name="文本框 18"/>
              <p:cNvSpPr/>
              <p:nvPr/>
            </p:nvSpPr>
            <p:spPr>
              <a:xfrm rot="16200000">
                <a:off x="-34920" y="3435480"/>
                <a:ext cx="1104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Caspase-1 45K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4" name="组合 15"/>
            <p:cNvGrpSpPr/>
            <p:nvPr/>
          </p:nvGrpSpPr>
          <p:grpSpPr>
            <a:xfrm>
              <a:off x="403200" y="4230360"/>
              <a:ext cx="3243240" cy="1266480"/>
              <a:chOff x="403200" y="4230360"/>
              <a:chExt cx="3243240" cy="1266480"/>
            </a:xfrm>
          </p:grpSpPr>
          <p:pic>
            <p:nvPicPr>
              <p:cNvPr id="245" name="图片 11" descr="IL1B3-1"/>
              <p:cNvPicPr/>
              <p:nvPr/>
            </p:nvPicPr>
            <p:blipFill>
              <a:blip r:embed="rId4"/>
              <a:srcRect l="895304" t="273401" r="741989" b="850168"/>
              <a:stretch/>
            </p:blipFill>
            <p:spPr>
              <a:xfrm>
                <a:off x="642600" y="4230360"/>
                <a:ext cx="876240" cy="1266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6" name="图片 12" descr="IL1B4-1"/>
              <p:cNvPicPr/>
              <p:nvPr/>
            </p:nvPicPr>
            <p:blipFill>
              <a:blip r:embed="rId5"/>
              <a:srcRect l="926571" t="282927" r="688000" b="799652"/>
              <a:stretch/>
            </p:blipFill>
            <p:spPr>
              <a:xfrm>
                <a:off x="2770920" y="4230360"/>
                <a:ext cx="875520" cy="1266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7" name="图片 13" descr="IL1B5-1"/>
              <p:cNvPicPr/>
              <p:nvPr/>
            </p:nvPicPr>
            <p:blipFill>
              <a:blip r:embed="rId6"/>
              <a:srcRect l="854467" t="248772" r="756484" b="824561"/>
              <a:stretch/>
            </p:blipFill>
            <p:spPr>
              <a:xfrm>
                <a:off x="1708200" y="4230360"/>
                <a:ext cx="873360" cy="1266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48" name="文本框 14"/>
              <p:cNvSpPr/>
              <p:nvPr/>
            </p:nvSpPr>
            <p:spPr>
              <a:xfrm rot="16200000">
                <a:off x="-25560" y="4660560"/>
                <a:ext cx="1104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IL-1β 31K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9" name="组合 21"/>
            <p:cNvGrpSpPr/>
            <p:nvPr/>
          </p:nvGrpSpPr>
          <p:grpSpPr>
            <a:xfrm>
              <a:off x="402480" y="312480"/>
              <a:ext cx="3245400" cy="1265400"/>
              <a:chOff x="402480" y="312480"/>
              <a:chExt cx="3245400" cy="1265400"/>
            </a:xfrm>
          </p:grpSpPr>
          <p:pic>
            <p:nvPicPr>
              <p:cNvPr id="250" name="图片 16" descr="NLRP4-1"/>
              <p:cNvPicPr/>
              <p:nvPr/>
            </p:nvPicPr>
            <p:blipFill>
              <a:blip r:embed="rId7"/>
              <a:srcRect l="892515" t="297436" r="686527" b="722711"/>
              <a:stretch/>
            </p:blipFill>
            <p:spPr>
              <a:xfrm>
                <a:off x="642600" y="312480"/>
                <a:ext cx="876240" cy="1265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51" name="图片 17" descr="NLRP5-1"/>
              <p:cNvPicPr/>
              <p:nvPr/>
            </p:nvPicPr>
            <p:blipFill>
              <a:blip r:embed="rId8"/>
              <a:srcRect l="811677" t="198535" r="767365" b="821612"/>
              <a:stretch/>
            </p:blipFill>
            <p:spPr>
              <a:xfrm>
                <a:off x="2771640" y="312480"/>
                <a:ext cx="876240" cy="1265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52" name="图片 19" descr="NLRP6-1"/>
              <p:cNvPicPr/>
              <p:nvPr/>
            </p:nvPicPr>
            <p:blipFill>
              <a:blip r:embed="rId9"/>
              <a:srcRect l="892793" t="198535" r="685886" b="821612"/>
              <a:stretch/>
            </p:blipFill>
            <p:spPr>
              <a:xfrm>
                <a:off x="1707120" y="312480"/>
                <a:ext cx="876960" cy="1265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53" name="文本框 20"/>
              <p:cNvSpPr/>
              <p:nvPr/>
            </p:nvSpPr>
            <p:spPr>
              <a:xfrm rot="16200000">
                <a:off x="-25920" y="824040"/>
                <a:ext cx="1103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NLRP3 108K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4" name="组合 5"/>
            <p:cNvGrpSpPr/>
            <p:nvPr/>
          </p:nvGrpSpPr>
          <p:grpSpPr>
            <a:xfrm>
              <a:off x="403200" y="5536440"/>
              <a:ext cx="3245040" cy="1266120"/>
              <a:chOff x="403200" y="5536440"/>
              <a:chExt cx="3245040" cy="1266120"/>
            </a:xfrm>
          </p:grpSpPr>
          <p:pic>
            <p:nvPicPr>
              <p:cNvPr id="255" name="图片 1" descr="GAPDH18-1"/>
              <p:cNvPicPr/>
              <p:nvPr/>
            </p:nvPicPr>
            <p:blipFill>
              <a:blip r:embed="rId10"/>
              <a:srcRect l="772286" t="122997" r="842571" b="959582"/>
              <a:stretch/>
            </p:blipFill>
            <p:spPr>
              <a:xfrm>
                <a:off x="642600" y="5536440"/>
                <a:ext cx="876240" cy="1266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56" name="图片 2" descr="GAPDH19-1"/>
              <p:cNvPicPr/>
              <p:nvPr/>
            </p:nvPicPr>
            <p:blipFill>
              <a:blip r:embed="rId11"/>
              <a:srcRect l="757423" t="277397" r="870868" b="829110"/>
              <a:stretch/>
            </p:blipFill>
            <p:spPr>
              <a:xfrm>
                <a:off x="1707120" y="5536440"/>
                <a:ext cx="875880" cy="1266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57" name="图片 3" descr="GAPDH20-1"/>
              <p:cNvPicPr/>
              <p:nvPr/>
            </p:nvPicPr>
            <p:blipFill>
              <a:blip r:embed="rId12"/>
              <a:srcRect l="992655" t="279655" r="629096" b="816897"/>
              <a:stretch/>
            </p:blipFill>
            <p:spPr>
              <a:xfrm>
                <a:off x="2771640" y="5536440"/>
                <a:ext cx="876600" cy="1266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58" name="文本框 50"/>
              <p:cNvSpPr/>
              <p:nvPr/>
            </p:nvSpPr>
            <p:spPr>
              <a:xfrm rot="16200000">
                <a:off x="-25560" y="6049440"/>
                <a:ext cx="1104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GAPDH 36K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9" name="文本框 52"/>
            <p:cNvSpPr/>
            <p:nvPr/>
          </p:nvSpPr>
          <p:spPr>
            <a:xfrm>
              <a:off x="485640" y="65160"/>
              <a:ext cx="354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/I  OE-MMP8+L/I  GW1929+OE-MMP8+L/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0" name="组合 2"/>
            <p:cNvGrpSpPr/>
            <p:nvPr/>
          </p:nvGrpSpPr>
          <p:grpSpPr>
            <a:xfrm>
              <a:off x="406800" y="1618200"/>
              <a:ext cx="3240000" cy="1266120"/>
              <a:chOff x="406800" y="1618200"/>
              <a:chExt cx="3240000" cy="1266120"/>
            </a:xfrm>
          </p:grpSpPr>
          <p:pic>
            <p:nvPicPr>
              <p:cNvPr id="261" name="图片 1" descr="GSDMD1-1"/>
              <p:cNvPicPr/>
              <p:nvPr/>
            </p:nvPicPr>
            <p:blipFill>
              <a:blip r:embed="rId13"/>
              <a:srcRect l="979944" t="184354" r="651811" b="928571"/>
              <a:stretch/>
            </p:blipFill>
            <p:spPr>
              <a:xfrm>
                <a:off x="2770920" y="1618200"/>
                <a:ext cx="875880" cy="1266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62" name="图片 3" descr="GSDMD5-1"/>
              <p:cNvPicPr/>
              <p:nvPr/>
            </p:nvPicPr>
            <p:blipFill>
              <a:blip r:embed="rId14"/>
              <a:srcRect l="36205" t="11234" r="36205" b="40094"/>
              <a:stretch/>
            </p:blipFill>
            <p:spPr>
              <a:xfrm>
                <a:off x="1699200" y="1618200"/>
                <a:ext cx="876600" cy="1266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63" name="文本框 5"/>
              <p:cNvSpPr/>
              <p:nvPr/>
            </p:nvSpPr>
            <p:spPr>
              <a:xfrm rot="16200000">
                <a:off x="-21960" y="2126520"/>
                <a:ext cx="1104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GSDMD 53K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64" name="图片 1" descr="GSDMD2-1-1"/>
              <p:cNvPicPr/>
              <p:nvPr/>
            </p:nvPicPr>
            <p:blipFill>
              <a:blip r:embed="rId15"/>
              <a:srcRect l="158259" t="34364" r="144494" b="176273"/>
              <a:stretch/>
            </p:blipFill>
            <p:spPr>
              <a:xfrm>
                <a:off x="627480" y="1618200"/>
                <a:ext cx="877320" cy="126612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7-23T00:59:22Z</dcterms:created>
  <dc:creator>xying</dc:creator>
  <dc:description/>
  <dc:language>en-US</dc:language>
  <cp:lastModifiedBy>一开始</cp:lastModifiedBy>
  <dcterms:modified xsi:type="dcterms:W3CDTF">2025-12-29T01:55:35Z</dcterms:modified>
  <cp:revision>2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37FBF2BC6944A51A7C070F1913B451A_13</vt:lpwstr>
  </property>
  <property fmtid="{D5CDD505-2E9C-101B-9397-08002B2CF9AE}" pid="3" name="KSOProductBuildVer">
    <vt:lpwstr>2052-12.1.0.24034</vt:lpwstr>
  </property>
</Properties>
</file>